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3" autoAdjust="0"/>
    <p:restoredTop sz="94660"/>
  </p:normalViewPr>
  <p:slideViewPr>
    <p:cSldViewPr snapToGrid="0">
      <p:cViewPr varScale="1">
        <p:scale>
          <a:sx n="154" d="100"/>
          <a:sy n="154" d="100"/>
        </p:scale>
        <p:origin x="162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75998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60441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05452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65528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727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5050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58985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7434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23633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32537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94836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5F6B1-7A9D-4B6D-AC6D-1761E32FD961}" type="datetimeFigureOut">
              <a:rPr lang="he-IL" smtClean="0"/>
              <a:t>כ"א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B609F-6D77-48CE-BC03-D5C26E2A5D13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62701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0072769"/>
              </p:ext>
            </p:extLst>
          </p:nvPr>
        </p:nvGraphicFramePr>
        <p:xfrm>
          <a:off x="2274075" y="886141"/>
          <a:ext cx="6830073" cy="218661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504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0452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1980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9570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4176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1908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4514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696582">
                <a:tc>
                  <a:txBody>
                    <a:bodyPr/>
                    <a:lstStyle/>
                    <a:p>
                      <a:pPr algn="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 smtClean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u="none" dirty="0">
                          <a:solidFill>
                            <a:schemeClr val="tx1"/>
                          </a:solidFill>
                          <a:effectLst/>
                        </a:rPr>
                        <a:t>No. with </a:t>
                      </a:r>
                      <a:r>
                        <a:rPr lang="en-US" sz="1200" b="1" u="none" dirty="0" err="1" smtClean="0">
                          <a:solidFill>
                            <a:schemeClr val="tx1"/>
                          </a:solidFill>
                          <a:effectLst/>
                        </a:rPr>
                        <a:t>RxLR</a:t>
                      </a:r>
                      <a:r>
                        <a:rPr lang="en-US" sz="1200" b="1" u="none" dirty="0" smtClean="0">
                          <a:solidFill>
                            <a:schemeClr val="tx1"/>
                          </a:solidFill>
                          <a:effectLst/>
                        </a:rPr>
                        <a:t>/DEER-like motifs </a:t>
                      </a:r>
                      <a:endParaRPr lang="en-US" sz="1200" b="1" u="none" dirty="0">
                        <a:solidFill>
                          <a:schemeClr val="tx1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29285">
                <a:tc>
                  <a:txBody>
                    <a:bodyPr/>
                    <a:lstStyle/>
                    <a:p>
                      <a:pPr algn="l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</a:rPr>
                        <a:t>No. </a:t>
                      </a:r>
                      <a:r>
                        <a:rPr lang="en-US" sz="1200" b="1" i="1" dirty="0">
                          <a:solidFill>
                            <a:schemeClr val="tx1"/>
                          </a:solidFill>
                          <a:effectLst/>
                        </a:rPr>
                        <a:t>M</a:t>
                      </a:r>
                      <a:r>
                        <a:rPr lang="en-US" sz="1200" b="1" i="1" dirty="0" smtClean="0">
                          <a:solidFill>
                            <a:schemeClr val="tx1"/>
                          </a:solidFill>
                          <a:effectLst/>
                        </a:rPr>
                        <a:t>. </a:t>
                      </a:r>
                      <a:r>
                        <a:rPr lang="en-US" sz="1200" b="1" i="1" dirty="0" err="1" smtClean="0">
                          <a:solidFill>
                            <a:schemeClr val="tx1"/>
                          </a:solidFill>
                          <a:effectLst/>
                        </a:rPr>
                        <a:t>javanica</a:t>
                      </a:r>
                      <a:r>
                        <a:rPr lang="en-US" sz="1200" b="1" dirty="0" smtClean="0">
                          <a:solidFill>
                            <a:schemeClr val="tx1"/>
                          </a:solidFill>
                          <a:effectLst/>
                        </a:rPr>
                        <a:t>  ORFs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dirty="0">
                          <a:effectLst/>
                        </a:rPr>
                        <a:t>REGEX</a:t>
                      </a:r>
                      <a:endParaRPr lang="en-US" sz="1200" b="1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dirty="0">
                          <a:effectLst/>
                        </a:rPr>
                        <a:t>HMM</a:t>
                      </a:r>
                      <a:endParaRPr lang="en-US" sz="1200" b="1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dirty="0" smtClean="0">
                          <a:effectLst/>
                        </a:rPr>
                        <a:t>Total redundancy</a:t>
                      </a:r>
                      <a:endParaRPr lang="en-US" sz="1200" b="1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dirty="0" err="1" smtClean="0">
                          <a:effectLst/>
                        </a:rPr>
                        <a:t>RxLR</a:t>
                      </a:r>
                      <a:r>
                        <a:rPr lang="en-US" sz="1200" b="1" dirty="0" smtClean="0">
                          <a:solidFill>
                            <a:srgbClr val="FF0000"/>
                          </a:solidFill>
                          <a:effectLst/>
                        </a:rPr>
                        <a:t>-</a:t>
                      </a:r>
                      <a:r>
                        <a:rPr lang="en-US" sz="1200" b="1" dirty="0" smtClean="0">
                          <a:effectLst/>
                        </a:rPr>
                        <a:t>like </a:t>
                      </a:r>
                      <a:r>
                        <a:rPr lang="en-US" sz="1200" b="1" baseline="0" dirty="0" smtClean="0">
                          <a:effectLst/>
                        </a:rPr>
                        <a:t> protein </a:t>
                      </a:r>
                      <a:r>
                        <a:rPr lang="en-US" sz="1200" b="1" dirty="0" smtClean="0">
                          <a:effectLst/>
                        </a:rPr>
                        <a:t> </a:t>
                      </a:r>
                      <a:r>
                        <a:rPr lang="en-US" sz="1200" b="1" dirty="0">
                          <a:effectLst/>
                        </a:rPr>
                        <a:t>candidate</a:t>
                      </a:r>
                      <a:endParaRPr lang="en-US" sz="1200" b="1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dirty="0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No.</a:t>
                      </a:r>
                      <a:r>
                        <a:rPr lang="en-US" sz="1200" b="1" baseline="0" dirty="0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 with SP, no TM</a:t>
                      </a:r>
                      <a:endParaRPr lang="en-US" sz="1200" b="1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553">
                <a:tc>
                  <a:txBody>
                    <a:bodyPr/>
                    <a:lstStyle/>
                    <a:p>
                      <a:pPr algn="l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dirty="0" err="1" smtClean="0">
                          <a:effectLst/>
                        </a:rPr>
                        <a:t>RxLR</a:t>
                      </a:r>
                      <a:r>
                        <a:rPr lang="en-US" sz="1200" b="1" dirty="0" smtClean="0">
                          <a:effectLst/>
                        </a:rPr>
                        <a:t> strict*</a:t>
                      </a:r>
                      <a:endParaRPr lang="en-US" sz="1200" b="1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97208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43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213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39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>
                          <a:effectLst/>
                        </a:rPr>
                        <a:t>217</a:t>
                      </a:r>
                      <a:endParaRPr lang="en-US" sz="120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2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3095">
                <a:tc>
                  <a:txBody>
                    <a:bodyPr/>
                    <a:lstStyle/>
                    <a:p>
                      <a:pPr algn="l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dirty="0" err="1" smtClean="0">
                          <a:effectLst/>
                        </a:rPr>
                        <a:t>RxLR</a:t>
                      </a:r>
                      <a:r>
                        <a:rPr lang="en-US" sz="1200" b="1" dirty="0" smtClean="0">
                          <a:effectLst/>
                        </a:rPr>
                        <a:t> relax**</a:t>
                      </a:r>
                      <a:endParaRPr lang="en-US" sz="1200" b="1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97208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218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1148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61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>
                          <a:effectLst/>
                        </a:rPr>
                        <a:t>1305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12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3095">
                <a:tc>
                  <a:txBody>
                    <a:bodyPr/>
                    <a:lstStyle/>
                    <a:p>
                      <a:pPr algn="l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b="1" dirty="0" err="1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RxLR</a:t>
                      </a:r>
                      <a:r>
                        <a:rPr lang="en-US" sz="1200" b="1" dirty="0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 relax 2***</a:t>
                      </a:r>
                      <a:endParaRPr lang="en-US" sz="1200" b="1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 smtClean="0">
                          <a:effectLst/>
                        </a:rPr>
                        <a:t>97208</a:t>
                      </a:r>
                      <a:endParaRPr lang="en-US" sz="12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87</a:t>
                      </a:r>
                      <a:endParaRPr lang="en-US" sz="12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1606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168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2525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1200" dirty="0" smtClean="0">
                          <a:effectLst/>
                          <a:latin typeface="+mj-lt"/>
                          <a:ea typeface="Calibri" panose="020F0502020204030204" pitchFamily="34" charset="0"/>
                          <a:cs typeface="+mj-cs"/>
                        </a:rPr>
                        <a:t>54</a:t>
                      </a:r>
                      <a:endParaRPr lang="en-US" sz="1200" dirty="0">
                        <a:effectLst/>
                        <a:latin typeface="+mj-lt"/>
                        <a:ea typeface="Calibri" panose="020F0502020204030204" pitchFamily="34" charset="0"/>
                        <a:cs typeface="+mj-cs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2274075" y="3395462"/>
            <a:ext cx="836644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P, signal peptide. TM, transmembrane domain.</a:t>
            </a:r>
          </a:p>
        </p:txBody>
      </p:sp>
      <p:sp>
        <p:nvSpPr>
          <p:cNvPr id="3" name="Rectangle 2"/>
          <p:cNvSpPr/>
          <p:nvPr/>
        </p:nvSpPr>
        <p:spPr>
          <a:xfrm>
            <a:off x="2274075" y="4245564"/>
            <a:ext cx="7943461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able S1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rediction of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x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like effectors in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ffect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f the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.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vanic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genome ORFs with different strengths of REGEX.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erformed according to </a:t>
            </a:r>
            <a:r>
              <a:rPr lang="de-DE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abima and Grünwald (Tabima and Grünwald 2019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 To conduct a search for additional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x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like effectors in M.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vanic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genome three scripts were used: 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*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x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trict motif patterns according to </a:t>
            </a:r>
            <a:r>
              <a:rPr lang="de-DE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abima and Grünwal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2019). These searches are based on REGEX matching. For th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x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otif, the REGEX reported by Haas et al. (2009) was used: (“^\w{10,40}\w{1,96}R\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\w{1,40}EER).  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**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x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otif relax mode: ("^\\w{1,96}R\\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\\w{1,40}[ED][ED][RKT]\\w{1,20}[WYL]")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***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Rx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motif relax2 mode:("^\\w{1,2000}R\\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w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\\w{1,70}[ED][ED][RKT]“)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8959390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06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gal Brown Miyara</dc:creator>
  <cp:lastModifiedBy>Sigal Brown Miyara</cp:lastModifiedBy>
  <cp:revision>6</cp:revision>
  <dcterms:created xsi:type="dcterms:W3CDTF">2021-11-22T13:35:02Z</dcterms:created>
  <dcterms:modified xsi:type="dcterms:W3CDTF">2021-11-25T12:43:09Z</dcterms:modified>
</cp:coreProperties>
</file>